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header&gt;</a:t>
            </a:r>
            <a:endParaRPr b="0" lang="en-US" sz="12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solidFill>
            <a:srgbClr val="ffffff"/>
          </a:solid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footer&gt;</a:t>
            </a:r>
            <a:endParaRPr b="0" lang="en-US" sz="12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0416FF6-B476-4F82-A3DF-9C55067E802B}"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PlaceHolder 1"/>
          <p:cNvSpPr>
            <a:spLocks noGrp="1"/>
          </p:cNvSpPr>
          <p:nvPr>
            <p:ph type="sldImg"/>
          </p:nvPr>
        </p:nvSpPr>
        <p:spPr>
          <a:xfrm>
            <a:off x="1144440" y="685800"/>
            <a:ext cx="4572000" cy="3429000"/>
          </a:xfrm>
          <a:prstGeom prst="rect">
            <a:avLst/>
          </a:prstGeom>
          <a:ln w="0">
            <a:noFill/>
          </a:ln>
        </p:spPr>
      </p:sp>
      <p:sp>
        <p:nvSpPr>
          <p:cNvPr id="51"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SimSun"/>
              </a:rPr>
              <a:t>Figure Ware_F2.  Relationship between sequence length differences in ortholologous introns and the presence of repetitive sequences.  Intron length difference are calculated as (length of the maize intron)–(length of the other species’ intron), such that negative values occur when the maize intron is shorter than its orthologue.  Each intron length difference is plotted twice, once against the repetitive content of the maize intron (red) and once against the repetitive content of the other species’ intron (blue).  (A)  Maize-sorghum orthologues.  (B)  Maize-rice orthologu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Documents and Settings\steinj\My Documents2\MAIZE_PROJECT\Accelerated region\Manuscript\Comp_gene_stats.xls</a:t>
            </a:r>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E81BB48-7806-4933-9DDD-7F8A275225E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4F3F055-9D3F-4B30-AD16-6E1338B4185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2AEB18C-0230-4A73-B208-7AE7E5AEDE5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7A659EF-D7E8-4DE3-8090-E521CA9C7C2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47F2B55-BC42-463E-8A64-F5EEFA97574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AA24DCA-07D8-41B7-B12C-169A6BBE93E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6AC747D-611F-4097-A740-AA81B685766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9072754-68C9-4D89-91BC-FF2D3587BB7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94BF15A-C551-4FDF-96C2-E532BD47145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B9AF2D5-1F01-4085-9061-F897D4C07D1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6FD2BCF-4471-4CAF-93CD-DF17A644B42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4BC4E91-334C-4B40-801F-5412C6C616B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C4466F5-C425-4E0A-8E06-ED27D0CD0874}"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Relationship Id="rId3"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 name=""/>
          <p:cNvSpPr/>
          <p:nvPr/>
        </p:nvSpPr>
        <p:spPr>
          <a:xfrm>
            <a:off x="187200" y="520560"/>
            <a:ext cx="651852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Figure S8. </a:t>
            </a:r>
            <a:r>
              <a:rPr b="1" lang="en-US" sz="1200" spc="-1" strike="noStrike">
                <a:solidFill>
                  <a:srgbClr val="000000"/>
                </a:solidFill>
                <a:latin typeface="Times New Roman"/>
                <a:ea typeface="SimSun"/>
              </a:rPr>
              <a:t>Relationship between sequence length differences in ortholologous introns and the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SimSun"/>
              </a:rPr>
              <a:t>presence of repetitive sequences</a:t>
            </a:r>
            <a:r>
              <a:rPr b="0" lang="en-US" sz="1200" spc="-1" strike="noStrike">
                <a:solidFill>
                  <a:srgbClr val="000000"/>
                </a:solidFill>
                <a:latin typeface="Times New Roman"/>
                <a:ea typeface="SimSun"/>
              </a:rPr>
              <a:t>.</a:t>
            </a:r>
            <a:endParaRPr b="0" lang="en-US" sz="1200" spc="-1" strike="noStrike">
              <a:solidFill>
                <a:srgbClr val="000000"/>
              </a:solidFill>
              <a:latin typeface="Arial"/>
            </a:endParaRPr>
          </a:p>
        </p:txBody>
      </p:sp>
      <p:pic>
        <p:nvPicPr>
          <p:cNvPr id="49" name="" descr=""/>
          <p:cNvPicPr/>
          <p:nvPr/>
        </p:nvPicPr>
        <p:blipFill>
          <a:blip r:embed="rId1"/>
          <a:srcRect l="5673" t="6634" r="13791" b="3035"/>
          <a:stretch/>
        </p:blipFill>
        <p:spPr>
          <a:xfrm>
            <a:off x="392040" y="1285920"/>
            <a:ext cx="6286680" cy="482112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0-15T05:20:36Z</dcterms:created>
  <dc:creator>fushengw</dc:creator>
  <dc:description/>
  <dc:language>en-US</dc:language>
  <cp:lastModifiedBy>fushengw</cp:lastModifiedBy>
  <dcterms:modified xsi:type="dcterms:W3CDTF">2009-10-15T05:22:00Z</dcterms:modified>
  <cp:revision>3</cp:revision>
  <dc:subject/>
  <dc:title>Slide 1</dc:title>
</cp:coreProperties>
</file>